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7A74CE4-C72E-4505-B686-B205C96EB4CF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5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5B6A516-2808-4F71-A6F2-BE2BC9E124D7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D94500-7695-4BE4-8D43-066C6E93E30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D606E6-CDEE-485E-87E5-C62B79E2FB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D62F81-4A87-4B3D-86EF-D5A27D3426A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9E4C9F-C75A-496D-89DE-C84F28FE0F5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10C34C-1D50-452F-916A-45400B72C15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BBC80D-39A8-4A7E-9899-6575925763B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1CD427-6A3B-41B6-B810-576F25BE60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646546-BD04-4A23-806B-9E762088AB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EB2877-33F2-4AEC-8AE4-8068334B93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1B5708-0AA8-4F9A-991E-1D22D06A0E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50C5B8-A30D-48D2-ABE4-85D258A4B7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8F9320-DE85-4276-8016-88B9F67468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21EDF6-E205-4E86-BF34-BF7156FF57AF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8"/>
          <p:cNvSpPr/>
          <p:nvPr/>
        </p:nvSpPr>
        <p:spPr>
          <a:xfrm>
            <a:off x="76320" y="5562720"/>
            <a:ext cx="67053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The images of STB03and BTS02 show that the former has some typical morphological traits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. oryzicol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such as a compact plant type, bigger seeds, and high similarity with rice, whereas the latter has traits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. crus-galli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such as geniculate culms, smaller seeds, and a loose typ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Group 16"/>
          <p:cNvGrpSpPr/>
          <p:nvPr/>
        </p:nvGrpSpPr>
        <p:grpSpPr>
          <a:xfrm>
            <a:off x="612000" y="3200400"/>
            <a:ext cx="2054880" cy="1382760"/>
            <a:chOff x="612000" y="3200400"/>
            <a:chExt cx="2054880" cy="1382760"/>
          </a:xfrm>
        </p:grpSpPr>
        <p:pic>
          <p:nvPicPr>
            <p:cNvPr id="50" name="Picture 2" descr="G:\F\B_ZhejiangUniversity\稗草叶绿体\修改\Untitled-1.tif"/>
            <p:cNvPicPr/>
            <p:nvPr/>
          </p:nvPicPr>
          <p:blipFill>
            <a:blip r:embed="rId1"/>
            <a:stretch/>
          </p:blipFill>
          <p:spPr>
            <a:xfrm>
              <a:off x="711000" y="3200400"/>
              <a:ext cx="1955880" cy="1382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TextBox 12"/>
            <p:cNvSpPr/>
            <p:nvPr/>
          </p:nvSpPr>
          <p:spPr>
            <a:xfrm>
              <a:off x="612000" y="3276360"/>
              <a:ext cx="64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Arial"/>
                  <a:ea typeface="Arial"/>
                </a:rPr>
                <a:t>STB0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13"/>
            <p:cNvSpPr/>
            <p:nvPr/>
          </p:nvSpPr>
          <p:spPr>
            <a:xfrm>
              <a:off x="612000" y="4066560"/>
              <a:ext cx="64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Arial"/>
                  <a:ea typeface="Arial"/>
                </a:rPr>
                <a:t>BTS0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3" name="Group 17"/>
          <p:cNvGrpSpPr/>
          <p:nvPr/>
        </p:nvGrpSpPr>
        <p:grpSpPr>
          <a:xfrm>
            <a:off x="685800" y="457200"/>
            <a:ext cx="3862440" cy="2473200"/>
            <a:chOff x="685800" y="457200"/>
            <a:chExt cx="3862440" cy="2473200"/>
          </a:xfrm>
        </p:grpSpPr>
        <p:pic>
          <p:nvPicPr>
            <p:cNvPr id="54" name="Picture 2" descr=""/>
            <p:cNvPicPr/>
            <p:nvPr/>
          </p:nvPicPr>
          <p:blipFill>
            <a:blip r:embed="rId2"/>
            <a:stretch/>
          </p:blipFill>
          <p:spPr>
            <a:xfrm>
              <a:off x="685800" y="457200"/>
              <a:ext cx="3862440" cy="2473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TextBox 14"/>
            <p:cNvSpPr/>
            <p:nvPr/>
          </p:nvSpPr>
          <p:spPr>
            <a:xfrm>
              <a:off x="1450080" y="457200"/>
              <a:ext cx="64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Arial"/>
                  <a:ea typeface="Arial"/>
                </a:rPr>
                <a:t>BTS0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15"/>
            <p:cNvSpPr/>
            <p:nvPr/>
          </p:nvSpPr>
          <p:spPr>
            <a:xfrm>
              <a:off x="3279240" y="457200"/>
              <a:ext cx="64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Arial"/>
                  <a:ea typeface="Arial"/>
                </a:rPr>
                <a:t>STB0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01T04:17:23Z</dcterms:created>
  <dc:creator>Chuyu YE</dc:creator>
  <dc:description/>
  <cp:keywords/>
  <dc:language>en-US</dc:language>
  <cp:lastModifiedBy>user</cp:lastModifiedBy>
  <dcterms:modified xsi:type="dcterms:W3CDTF">2014-11-01T04:17:41Z</dcterms:modified>
  <cp:revision>1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8.1.0.2424</vt:lpwstr>
  </property>
</Properties>
</file>